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56"/>
    <p:restoredTop sz="95690"/>
  </p:normalViewPr>
  <p:slideViewPr>
    <p:cSldViewPr snapToGrid="0" snapToObjects="1">
      <p:cViewPr varScale="1">
        <p:scale>
          <a:sx n="116" d="100"/>
          <a:sy n="116" d="100"/>
        </p:scale>
        <p:origin x="1728" y="1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60F241-53A8-2A48-9F3E-C326E171246C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C1359-21C4-4543-92A9-0CF0057A0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62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5C1359-21C4-4543-92A9-0CF0057A0B0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413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517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27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0263" y="274640"/>
            <a:ext cx="2227262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1" y="274640"/>
            <a:ext cx="6532563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79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49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17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1" y="1600202"/>
            <a:ext cx="4379913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7613" y="1600202"/>
            <a:ext cx="4379912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528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98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4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84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73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316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E45E6-ED81-5042-B33C-957D5B8C0701}" type="datetimeFigureOut">
              <a:rPr lang="en-US" smtClean="0"/>
              <a:t>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D198D-93F4-CD4B-A595-FB51A189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153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260" y="4209474"/>
            <a:ext cx="6677354" cy="1262891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284927" y="570438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6321" y="867214"/>
            <a:ext cx="1318154" cy="138979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43621" y="839221"/>
            <a:ext cx="1571276" cy="140490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14857" y="851240"/>
            <a:ext cx="1431412" cy="140577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17053" y="2189449"/>
            <a:ext cx="1920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Lineage :</a:t>
            </a:r>
          </a:p>
          <a:p>
            <a:r>
              <a:rPr lang="en-US" sz="900" dirty="0">
                <a:latin typeface="Arial"/>
                <a:cs typeface="Arial"/>
              </a:rPr>
              <a:t>CD11b,Gr-1, CD3,B220, Ter117 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501EE90-A964-214F-B0B7-C55D4680CAB5}"/>
              </a:ext>
            </a:extLst>
          </p:cNvPr>
          <p:cNvGrpSpPr/>
          <p:nvPr/>
        </p:nvGrpSpPr>
        <p:grpSpPr>
          <a:xfrm>
            <a:off x="467875" y="842389"/>
            <a:ext cx="1645116" cy="1401739"/>
            <a:chOff x="881748" y="573002"/>
            <a:chExt cx="1479956" cy="155002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81748" y="573002"/>
              <a:ext cx="1479956" cy="155002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044595" y="582677"/>
              <a:ext cx="3556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Lin-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 rot="16200000">
            <a:off x="171372" y="1572300"/>
            <a:ext cx="42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SS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38212" y="1238155"/>
            <a:ext cx="34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2.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689689" y="2189449"/>
            <a:ext cx="4861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Sca-1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233125" y="1947522"/>
            <a:ext cx="377064" cy="230832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Arial"/>
                <a:cs typeface="Arial"/>
              </a:rPr>
              <a:t>cKit</a:t>
            </a:r>
            <a:endParaRPr lang="en-US" sz="90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339264" y="2189449"/>
            <a:ext cx="4797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CD3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70211" y="2189449"/>
            <a:ext cx="5439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CD150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5632207" y="1844666"/>
            <a:ext cx="4797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CD48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707905" y="1134461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21008" y="916020"/>
            <a:ext cx="707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HSPCs(LSK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321457" y="869224"/>
            <a:ext cx="701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HSCs</a:t>
            </a:r>
          </a:p>
          <a:p>
            <a:r>
              <a:rPr lang="en-US" sz="900"/>
              <a:t>(CD34-LSK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899897" y="869224"/>
            <a:ext cx="72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           HPCs</a:t>
            </a:r>
          </a:p>
          <a:p>
            <a:r>
              <a:rPr lang="en-US" sz="900"/>
              <a:t>(CD34+LSK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625897" y="1583599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17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272965" y="1673752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83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833293" y="1952340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8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087827" y="1951385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18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997675" y="881234"/>
            <a:ext cx="3130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71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316355" y="612144"/>
            <a:ext cx="146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119280" y="612144"/>
            <a:ext cx="15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C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718271" y="612144"/>
            <a:ext cx="277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D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16572" y="2610363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E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257731" y="2610363"/>
            <a:ext cx="1462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F</a:t>
            </a:r>
          </a:p>
        </p:txBody>
      </p:sp>
      <p:cxnSp>
        <p:nvCxnSpPr>
          <p:cNvPr id="43" name="Straight Arrow Connector 42"/>
          <p:cNvCxnSpPr/>
          <p:nvPr/>
        </p:nvCxnSpPr>
        <p:spPr>
          <a:xfrm>
            <a:off x="4781128" y="2304865"/>
            <a:ext cx="204391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6446705" y="2299149"/>
            <a:ext cx="204391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rot="16200000">
            <a:off x="5761407" y="1677996"/>
            <a:ext cx="221353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cxnSpLocks/>
          </p:cNvCxnSpPr>
          <p:nvPr/>
        </p:nvCxnSpPr>
        <p:spPr>
          <a:xfrm>
            <a:off x="1300904" y="2337786"/>
            <a:ext cx="453789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585832" y="645399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Gated: Lin-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16342" y="645399"/>
            <a:ext cx="11705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Gated: Total BM cells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4309562" y="645399"/>
            <a:ext cx="7200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Gated: LSK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953367" y="645399"/>
            <a:ext cx="7200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Gated: LSK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41624" y="2681661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CD34-/LSK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428491" y="2610363"/>
            <a:ext cx="15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G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479628" y="2681661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Gated: Lin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036B72E-C60D-CC41-A5C8-4B5F45198B03}"/>
              </a:ext>
            </a:extLst>
          </p:cNvPr>
          <p:cNvSpPr txBox="1"/>
          <p:nvPr/>
        </p:nvSpPr>
        <p:spPr>
          <a:xfrm>
            <a:off x="2353778" y="4210424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CD34-/LSK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D4CE581-5AC0-3E42-8A3F-40BF50D1C054}"/>
              </a:ext>
            </a:extLst>
          </p:cNvPr>
          <p:cNvSpPr txBox="1"/>
          <p:nvPr/>
        </p:nvSpPr>
        <p:spPr>
          <a:xfrm>
            <a:off x="4298687" y="4224776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CD34-/LSK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28D945B-85F7-E542-BB67-A86C6B03D015}"/>
              </a:ext>
            </a:extLst>
          </p:cNvPr>
          <p:cNvSpPr txBox="1"/>
          <p:nvPr/>
        </p:nvSpPr>
        <p:spPr>
          <a:xfrm>
            <a:off x="3932784" y="4152326"/>
            <a:ext cx="152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J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A3982F8-5279-6F41-BEEA-5771A3E714E3}"/>
              </a:ext>
            </a:extLst>
          </p:cNvPr>
          <p:cNvSpPr txBox="1"/>
          <p:nvPr/>
        </p:nvSpPr>
        <p:spPr>
          <a:xfrm>
            <a:off x="5600039" y="4152326"/>
            <a:ext cx="298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K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9B07960-8F92-3A4D-8A8B-54ACDC1EC82F}"/>
              </a:ext>
            </a:extLst>
          </p:cNvPr>
          <p:cNvSpPr txBox="1"/>
          <p:nvPr/>
        </p:nvSpPr>
        <p:spPr>
          <a:xfrm>
            <a:off x="5836300" y="4210424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D34-/LSK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532B570-6BBE-6B48-9B63-6DF78487ECD3}"/>
              </a:ext>
            </a:extLst>
          </p:cNvPr>
          <p:cNvSpPr txBox="1"/>
          <p:nvPr/>
        </p:nvSpPr>
        <p:spPr>
          <a:xfrm>
            <a:off x="497849" y="4152326"/>
            <a:ext cx="15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H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D1D8428-A977-0D44-B147-6FBE1E3D1190}"/>
              </a:ext>
            </a:extLst>
          </p:cNvPr>
          <p:cNvSpPr txBox="1"/>
          <p:nvPr/>
        </p:nvSpPr>
        <p:spPr>
          <a:xfrm>
            <a:off x="2165471" y="4152326"/>
            <a:ext cx="15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Arial"/>
                <a:cs typeface="Arial"/>
              </a:rPr>
              <a:t>I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3856195-FBBB-F941-BCA1-99A48410A6F3}"/>
              </a:ext>
            </a:extLst>
          </p:cNvPr>
          <p:cNvSpPr txBox="1"/>
          <p:nvPr/>
        </p:nvSpPr>
        <p:spPr>
          <a:xfrm>
            <a:off x="810880" y="4210424"/>
            <a:ext cx="7035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D34-/LSK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65CC0B5D-199D-9449-AE06-23DE3DDB113B}"/>
              </a:ext>
            </a:extLst>
          </p:cNvPr>
          <p:cNvCxnSpPr/>
          <p:nvPr/>
        </p:nvCxnSpPr>
        <p:spPr>
          <a:xfrm>
            <a:off x="3118812" y="2304865"/>
            <a:ext cx="204391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D4D2C1D4-6F05-734E-B434-57CF3CA68556}"/>
              </a:ext>
            </a:extLst>
          </p:cNvPr>
          <p:cNvCxnSpPr>
            <a:cxnSpLocks/>
          </p:cNvCxnSpPr>
          <p:nvPr/>
        </p:nvCxnSpPr>
        <p:spPr>
          <a:xfrm rot="16200000">
            <a:off x="2341426" y="1826707"/>
            <a:ext cx="204391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7" name="Picture 56">
            <a:extLst>
              <a:ext uri="{FF2B5EF4-FFF2-40B4-BE49-F238E27FC236}">
                <a16:creationId xmlns:a16="http://schemas.microsoft.com/office/drawing/2014/main" id="{B251E5D1-32FE-7746-98BA-718FC17F27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3025" y="2629743"/>
            <a:ext cx="6273800" cy="16002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9AD5F4E-7F47-B344-B1CC-E18CED9737C9}"/>
              </a:ext>
            </a:extLst>
          </p:cNvPr>
          <p:cNvSpPr/>
          <p:nvPr/>
        </p:nvSpPr>
        <p:spPr>
          <a:xfrm>
            <a:off x="0" y="11819"/>
            <a:ext cx="877591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114300" algn="l"/>
              </a:tabLst>
            </a:pPr>
            <a:r>
              <a:rPr lang="en-US" sz="1100" b="1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1 Fig</a:t>
            </a:r>
            <a:endParaRPr lang="en-US" sz="1100" dirty="0">
              <a:effectLst/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3564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29</TotalTime>
  <Words>86</Words>
  <Application>Microsoft Macintosh PowerPoint</Application>
  <PresentationFormat>On-screen Show (4:3)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rly</dc:creator>
  <cp:lastModifiedBy>Microsoft Office User</cp:lastModifiedBy>
  <cp:revision>208</cp:revision>
  <cp:lastPrinted>2019-12-19T11:23:40Z</cp:lastPrinted>
  <dcterms:created xsi:type="dcterms:W3CDTF">2019-06-24T07:55:27Z</dcterms:created>
  <dcterms:modified xsi:type="dcterms:W3CDTF">2021-02-12T15:11:07Z</dcterms:modified>
</cp:coreProperties>
</file>